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72" r:id="rId2"/>
    <p:sldId id="257" r:id="rId3"/>
    <p:sldId id="258" r:id="rId4"/>
    <p:sldId id="269" r:id="rId5"/>
    <p:sldId id="270" r:id="rId6"/>
    <p:sldId id="271" r:id="rId7"/>
    <p:sldId id="264" r:id="rId8"/>
    <p:sldId id="260" r:id="rId9"/>
    <p:sldId id="261" r:id="rId10"/>
    <p:sldId id="262" r:id="rId11"/>
    <p:sldId id="263" r:id="rId12"/>
    <p:sldId id="273" r:id="rId13"/>
    <p:sldId id="265" r:id="rId14"/>
    <p:sldId id="266" r:id="rId1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microsoft.com/office/2016/11/relationships/changesInfo" Target="changesInfos/changesInfo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lder, Noemi (PSY)" userId="0fce9ed4-cbda-4a05-8036-299649bcf1a4" providerId="ADAL" clId="{56002C20-7599-E84E-B2BF-66FA7FF6555D}"/>
    <pc:docChg chg="modSld">
      <pc:chgData name="Walder, Noemi (PSY)" userId="0fce9ed4-cbda-4a05-8036-299649bcf1a4" providerId="ADAL" clId="{56002C20-7599-E84E-B2BF-66FA7FF6555D}" dt="2024-10-01T17:25:42.115" v="100" actId="20577"/>
      <pc:docMkLst>
        <pc:docMk/>
      </pc:docMkLst>
      <pc:sldChg chg="modSp mod">
        <pc:chgData name="Walder, Noemi (PSY)" userId="0fce9ed4-cbda-4a05-8036-299649bcf1a4" providerId="ADAL" clId="{56002C20-7599-E84E-B2BF-66FA7FF6555D}" dt="2024-10-01T17:25:01.551" v="76" actId="20577"/>
        <pc:sldMkLst>
          <pc:docMk/>
          <pc:sldMk cId="2360353006" sldId="257"/>
        </pc:sldMkLst>
        <pc:spChg chg="mod">
          <ac:chgData name="Walder, Noemi (PSY)" userId="0fce9ed4-cbda-4a05-8036-299649bcf1a4" providerId="ADAL" clId="{56002C20-7599-E84E-B2BF-66FA7FF6555D}" dt="2024-10-01T17:25:01.551" v="76" actId="20577"/>
          <ac:spMkLst>
            <pc:docMk/>
            <pc:sldMk cId="2360353006" sldId="257"/>
            <ac:spMk id="4" creationId="{9B198149-9A70-4BC1-6040-5909097018EB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07.183" v="78" actId="20577"/>
        <pc:sldMkLst>
          <pc:docMk/>
          <pc:sldMk cId="376767204" sldId="258"/>
        </pc:sldMkLst>
        <pc:spChg chg="mod">
          <ac:chgData name="Walder, Noemi (PSY)" userId="0fce9ed4-cbda-4a05-8036-299649bcf1a4" providerId="ADAL" clId="{56002C20-7599-E84E-B2BF-66FA7FF6555D}" dt="2024-10-01T17:25:07.183" v="78" actId="20577"/>
          <ac:spMkLst>
            <pc:docMk/>
            <pc:sldMk cId="376767204" sldId="258"/>
            <ac:spMk id="4" creationId="{E83CD405-04C4-CD67-8CFE-8D08745A5D5E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25.022" v="88" actId="20577"/>
        <pc:sldMkLst>
          <pc:docMk/>
          <pc:sldMk cId="158174221" sldId="260"/>
        </pc:sldMkLst>
        <pc:spChg chg="mod">
          <ac:chgData name="Walder, Noemi (PSY)" userId="0fce9ed4-cbda-4a05-8036-299649bcf1a4" providerId="ADAL" clId="{56002C20-7599-E84E-B2BF-66FA7FF6555D}" dt="2024-10-01T17:25:25.022" v="88" actId="20577"/>
          <ac:spMkLst>
            <pc:docMk/>
            <pc:sldMk cId="158174221" sldId="260"/>
            <ac:spMk id="4" creationId="{FB9F60CB-97E8-2A7C-AD62-37A3DEDD5B1C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27.731" v="90" actId="20577"/>
        <pc:sldMkLst>
          <pc:docMk/>
          <pc:sldMk cId="2703079458" sldId="261"/>
        </pc:sldMkLst>
        <pc:spChg chg="mod">
          <ac:chgData name="Walder, Noemi (PSY)" userId="0fce9ed4-cbda-4a05-8036-299649bcf1a4" providerId="ADAL" clId="{56002C20-7599-E84E-B2BF-66FA7FF6555D}" dt="2024-10-01T17:25:27.731" v="90" actId="20577"/>
          <ac:spMkLst>
            <pc:docMk/>
            <pc:sldMk cId="2703079458" sldId="261"/>
            <ac:spMk id="4" creationId="{DB0093F4-4B7D-893F-12DB-80FBD37D5CA9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30.664" v="92" actId="20577"/>
        <pc:sldMkLst>
          <pc:docMk/>
          <pc:sldMk cId="1643853241" sldId="262"/>
        </pc:sldMkLst>
        <pc:spChg chg="mod">
          <ac:chgData name="Walder, Noemi (PSY)" userId="0fce9ed4-cbda-4a05-8036-299649bcf1a4" providerId="ADAL" clId="{56002C20-7599-E84E-B2BF-66FA7FF6555D}" dt="2024-10-01T17:25:30.664" v="92" actId="20577"/>
          <ac:spMkLst>
            <pc:docMk/>
            <pc:sldMk cId="1643853241" sldId="262"/>
            <ac:spMk id="3" creationId="{819CA01B-81C5-1D73-EFC7-E02F4C2FEC6D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34.222" v="94" actId="20577"/>
        <pc:sldMkLst>
          <pc:docMk/>
          <pc:sldMk cId="3934936600" sldId="263"/>
        </pc:sldMkLst>
        <pc:spChg chg="mod">
          <ac:chgData name="Walder, Noemi (PSY)" userId="0fce9ed4-cbda-4a05-8036-299649bcf1a4" providerId="ADAL" clId="{56002C20-7599-E84E-B2BF-66FA7FF6555D}" dt="2024-10-01T17:25:34.222" v="94" actId="20577"/>
          <ac:spMkLst>
            <pc:docMk/>
            <pc:sldMk cId="3934936600" sldId="263"/>
            <ac:spMk id="8" creationId="{8F618B7C-DF81-278C-11D8-1BF2224E023C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22.020" v="86" actId="20577"/>
        <pc:sldMkLst>
          <pc:docMk/>
          <pc:sldMk cId="2165278947" sldId="264"/>
        </pc:sldMkLst>
        <pc:spChg chg="mod">
          <ac:chgData name="Walder, Noemi (PSY)" userId="0fce9ed4-cbda-4a05-8036-299649bcf1a4" providerId="ADAL" clId="{56002C20-7599-E84E-B2BF-66FA7FF6555D}" dt="2024-10-01T17:25:22.020" v="86" actId="20577"/>
          <ac:spMkLst>
            <pc:docMk/>
            <pc:sldMk cId="2165278947" sldId="264"/>
            <ac:spMk id="3" creationId="{AA099E43-7CFD-129C-A76E-918B42206E3F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39.487" v="98" actId="20577"/>
        <pc:sldMkLst>
          <pc:docMk/>
          <pc:sldMk cId="3744214464" sldId="265"/>
        </pc:sldMkLst>
        <pc:spChg chg="mod">
          <ac:chgData name="Walder, Noemi (PSY)" userId="0fce9ed4-cbda-4a05-8036-299649bcf1a4" providerId="ADAL" clId="{56002C20-7599-E84E-B2BF-66FA7FF6555D}" dt="2024-10-01T17:25:39.487" v="98" actId="20577"/>
          <ac:spMkLst>
            <pc:docMk/>
            <pc:sldMk cId="3744214464" sldId="265"/>
            <ac:spMk id="4" creationId="{936F5781-95F1-7C27-3331-2AF7269214D8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42.115" v="100" actId="20577"/>
        <pc:sldMkLst>
          <pc:docMk/>
          <pc:sldMk cId="1528008818" sldId="266"/>
        </pc:sldMkLst>
        <pc:spChg chg="mod">
          <ac:chgData name="Walder, Noemi (PSY)" userId="0fce9ed4-cbda-4a05-8036-299649bcf1a4" providerId="ADAL" clId="{56002C20-7599-E84E-B2BF-66FA7FF6555D}" dt="2024-10-01T17:25:42.115" v="100" actId="20577"/>
          <ac:spMkLst>
            <pc:docMk/>
            <pc:sldMk cId="1528008818" sldId="266"/>
            <ac:spMk id="4" creationId="{3858A70B-7AC6-66CA-B046-CC5A7BC3E379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13.724" v="80" actId="20577"/>
        <pc:sldMkLst>
          <pc:docMk/>
          <pc:sldMk cId="4099362751" sldId="269"/>
        </pc:sldMkLst>
        <pc:spChg chg="mod">
          <ac:chgData name="Walder, Noemi (PSY)" userId="0fce9ed4-cbda-4a05-8036-299649bcf1a4" providerId="ADAL" clId="{56002C20-7599-E84E-B2BF-66FA7FF6555D}" dt="2024-10-01T17:25:13.724" v="80" actId="20577"/>
          <ac:spMkLst>
            <pc:docMk/>
            <pc:sldMk cId="4099362751" sldId="269"/>
            <ac:spMk id="4" creationId="{C72B4DFB-0318-89E6-0BB5-08DB39502FF1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16.205" v="82" actId="20577"/>
        <pc:sldMkLst>
          <pc:docMk/>
          <pc:sldMk cId="430116688" sldId="270"/>
        </pc:sldMkLst>
        <pc:spChg chg="mod">
          <ac:chgData name="Walder, Noemi (PSY)" userId="0fce9ed4-cbda-4a05-8036-299649bcf1a4" providerId="ADAL" clId="{56002C20-7599-E84E-B2BF-66FA7FF6555D}" dt="2024-10-01T17:25:16.205" v="82" actId="20577"/>
          <ac:spMkLst>
            <pc:docMk/>
            <pc:sldMk cId="430116688" sldId="270"/>
            <ac:spMk id="4" creationId="{CAA3EE51-F36A-D8CE-8CFD-5CDF306D2488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18.706" v="84" actId="20577"/>
        <pc:sldMkLst>
          <pc:docMk/>
          <pc:sldMk cId="687639659" sldId="271"/>
        </pc:sldMkLst>
        <pc:spChg chg="mod">
          <ac:chgData name="Walder, Noemi (PSY)" userId="0fce9ed4-cbda-4a05-8036-299649bcf1a4" providerId="ADAL" clId="{56002C20-7599-E84E-B2BF-66FA7FF6555D}" dt="2024-10-01T17:25:18.706" v="84" actId="20577"/>
          <ac:spMkLst>
            <pc:docMk/>
            <pc:sldMk cId="687639659" sldId="271"/>
            <ac:spMk id="4" creationId="{62363FD0-DD05-B57C-CC79-5F5219D98698}"/>
          </ac:spMkLst>
        </pc:spChg>
        <pc:picChg chg="mod">
          <ac:chgData name="Walder, Noemi (PSY)" userId="0fce9ed4-cbda-4a05-8036-299649bcf1a4" providerId="ADAL" clId="{56002C20-7599-E84E-B2BF-66FA7FF6555D}" dt="2024-10-01T16:27:23.700" v="42" actId="1035"/>
          <ac:picMkLst>
            <pc:docMk/>
            <pc:sldMk cId="687639659" sldId="271"/>
            <ac:picMk id="2" creationId="{AB83B71A-72C8-72C8-9E92-48CEBD28C88F}"/>
          </ac:picMkLst>
        </pc:picChg>
      </pc:sldChg>
      <pc:sldChg chg="modSp mod">
        <pc:chgData name="Walder, Noemi (PSY)" userId="0fce9ed4-cbda-4a05-8036-299649bcf1a4" providerId="ADAL" clId="{56002C20-7599-E84E-B2BF-66FA7FF6555D}" dt="2024-10-01T16:26:44.035" v="20" actId="20577"/>
        <pc:sldMkLst>
          <pc:docMk/>
          <pc:sldMk cId="3072245065" sldId="272"/>
        </pc:sldMkLst>
        <pc:spChg chg="mod">
          <ac:chgData name="Walder, Noemi (PSY)" userId="0fce9ed4-cbda-4a05-8036-299649bcf1a4" providerId="ADAL" clId="{56002C20-7599-E84E-B2BF-66FA7FF6555D}" dt="2024-10-01T16:26:44.035" v="20" actId="20577"/>
          <ac:spMkLst>
            <pc:docMk/>
            <pc:sldMk cId="3072245065" sldId="272"/>
            <ac:spMk id="3" creationId="{0F2F8C5E-3156-8CD3-B10F-ADEDDA76AB95}"/>
          </ac:spMkLst>
        </pc:spChg>
      </pc:sldChg>
      <pc:sldChg chg="modSp mod">
        <pc:chgData name="Walder, Noemi (PSY)" userId="0fce9ed4-cbda-4a05-8036-299649bcf1a4" providerId="ADAL" clId="{56002C20-7599-E84E-B2BF-66FA7FF6555D}" dt="2024-10-01T17:25:37.050" v="96" actId="20577"/>
        <pc:sldMkLst>
          <pc:docMk/>
          <pc:sldMk cId="3291049125" sldId="273"/>
        </pc:sldMkLst>
        <pc:spChg chg="mod">
          <ac:chgData name="Walder, Noemi (PSY)" userId="0fce9ed4-cbda-4a05-8036-299649bcf1a4" providerId="ADAL" clId="{56002C20-7599-E84E-B2BF-66FA7FF6555D}" dt="2024-10-01T17:25:37.050" v="96" actId="20577"/>
          <ac:spMkLst>
            <pc:docMk/>
            <pc:sldMk cId="3291049125" sldId="273"/>
            <ac:spMk id="5" creationId="{4F19A571-53A4-12C0-E1F8-F31C6CAC55BD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BB3FFE-A5DE-F943-80CE-014E15DEB535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DBAB89-6164-9845-89C0-F37765E95842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03357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0DBAB89-6164-9845-89C0-F37765E95842}" type="slidenum">
              <a:rPr lang="de-CH" smtClean="0"/>
              <a:t>14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664157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1E8F44C-7F22-64E2-E81E-9F119428A6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A7DD485-1A70-DE9D-58FD-3586371C2C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E294945-8CB7-6B83-217C-4899E1009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1391EAA-45E8-64FC-E8C2-2E82DD3A21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3B53C8A-3904-DE51-CBDB-395E9E62E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23004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E2A2896-2F69-8D13-5B82-3D6F77743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9A15310-A261-4A61-DCC2-C05BF5D0FF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9E810C4-A767-1B06-9AFF-88E325B34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A92D392-8FBA-AF07-0542-F79446067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C593707-DA3C-900B-99C4-2D441E0BA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62097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EAF252C3-BE5B-AFCF-5CF5-72AFA7854D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BAD2A09-50EE-61D4-4FEE-B0CDF2AA52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94824AC-6975-5932-5324-BE5F60786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DE657F1-F223-D30A-BB7E-F6DD40AA7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C7F7042-02EE-4A18-5E3A-FD2F57354B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91859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207C6D-B2EC-D712-96FF-DD1241AD5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9A93E40-8124-17A8-5E3B-8AAA877DF5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7599565-B20F-CBB3-7F4E-02BBD8990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E68BB82-CB26-6E1E-8C3A-120DC0158B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3F3B153-D3F6-0553-9B84-82DAD00802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60840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E059643-ED66-171D-15F4-953624A388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62FAC01-E6F3-3703-5A19-484F7815C7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CB76450-D02D-67D1-673A-3DD733E931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69AFB68-CEFD-1B52-F5E3-49B695677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2C75367-7424-E734-6303-87D249E59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00559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612B85A-271D-2F6E-C412-CA1F91576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1661DBE-420B-5D27-C128-E349099123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EB46FAA0-C213-811D-A00F-E5ADF589B4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EC55B8C-1D65-1553-2DDE-1FE559120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55BAC39-A0B0-8424-AC69-6F08D0646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C5074EF-88CF-335A-547F-81306A337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43308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EEF632-D612-6658-8E2D-B4932BFBC9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2A59B24-4E32-71F8-0E0E-31C8E3AA2E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A69B094-D1EE-E9CC-F80E-81BCBB83FE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5D392B18-8270-0389-3B31-B5F9FEE4EE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8BE6C43-3E42-57CF-C362-F536032E84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348F289-EF2F-E258-11B4-81A251F7C1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19F1849-8614-DF91-00C4-8C1D1F0AA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EEE1576F-3E93-ACF8-B396-8C94A3E1D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21109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8E7B054-4FA4-9D97-BCB8-EBC7D8C514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48E1911-62E8-297D-287D-76DA9A628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DE66F45D-DC2E-D458-3929-2CCD638CE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AD25FA4A-1FFA-74AB-CAD7-0BAB725D3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53847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1F1C1FC-E998-48C6-2C42-8B06E1E318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0A1A1FC-D9B5-8F11-D0FC-BD7F94636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E459D84-8A91-7243-BAA7-AC4FE996B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40565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DEB9CE-0BB0-F416-32AE-49E12993A6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A5629BF-8271-83DC-8F6D-D61121B2C3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323A795-C098-BDE0-9889-0E33F3085E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8103DC0-26CD-7DB0-1D46-232789193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EAEC243-358E-1941-0B58-1A1302127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5EF2FC5-B8B1-3404-3266-7ACD1A6AB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766790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99C016C-7651-50FF-7A2C-471CED6E9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494F6445-4DA3-08E1-F541-53F84BEB67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CF04478-286E-C7EB-D26A-7EFA407304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6BCEA3A-9C61-E6F3-9ADF-9D12D463D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9F5655A-7A17-9AD1-422E-EB55292698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3428310-9A2C-A073-E32E-2CA444FAC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91581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4BDBB17B-8E42-46FF-4B84-041549801C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C618F47-BFE9-951E-2BED-10F6FC8530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1DBAE94-B991-B57E-7D23-C03A98FB38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F920663-E2C8-4653-BC62-EADCDED6BCA2}" type="datetimeFigureOut">
              <a:rPr lang="de-CH" smtClean="0"/>
              <a:t>01.10.24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B55298A-DD0A-7CC9-8313-C7129A8767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C27C435-99F9-A2CC-73F6-A274186DFA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A498A9-850E-4B60-8458-0105B6F59CDE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9809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0F2F8C5E-3156-8CD3-B10F-ADEDDA76AB95}"/>
              </a:ext>
            </a:extLst>
          </p:cNvPr>
          <p:cNvSpPr txBox="1"/>
          <p:nvPr/>
        </p:nvSpPr>
        <p:spPr>
          <a:xfrm>
            <a:off x="945931" y="704825"/>
            <a:ext cx="10436772" cy="16698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lnSpc>
                <a:spcPct val="200000"/>
              </a:lnSpc>
            </a:pPr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Multimedia Appendix</a:t>
            </a:r>
          </a:p>
          <a:p>
            <a:pPr lvl="0">
              <a:lnSpc>
                <a:spcPct val="200000"/>
              </a:lnSpc>
            </a:pPr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rest Plots for all Meta Analyses</a:t>
            </a:r>
            <a:endParaRPr lang="de-CH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indent="457200">
              <a:lnSpc>
                <a:spcPct val="200000"/>
              </a:lnSpc>
            </a:pP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following figures display the forest plots for all computed meta analyses. </a:t>
            </a:r>
            <a:endParaRPr lang="de-CH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22450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3BC3DDBA-63C2-B28B-E62D-EDE91AEDC4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2" y="0"/>
            <a:ext cx="12169535" cy="6858000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819CA01B-81C5-1D73-EFC7-E02F4C2FEC6D}"/>
              </a:ext>
            </a:extLst>
          </p:cNvPr>
          <p:cNvSpPr txBox="1"/>
          <p:nvPr/>
        </p:nvSpPr>
        <p:spPr>
          <a:xfrm>
            <a:off x="525516" y="5855803"/>
            <a:ext cx="10815145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9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with the moderator age group (i.e., children (&gt;10 years), adolescents (11-17 years, young adults (&gt;18 years)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385324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48C5F024-C2E8-F647-1F4B-68A1693C0F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2" y="0"/>
            <a:ext cx="12169535" cy="6858000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8F618B7C-DF81-278C-11D8-1BF2224E023C}"/>
              </a:ext>
            </a:extLst>
          </p:cNvPr>
          <p:cNvSpPr txBox="1"/>
          <p:nvPr/>
        </p:nvSpPr>
        <p:spPr>
          <a:xfrm>
            <a:off x="362606" y="5451739"/>
            <a:ext cx="11466786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10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with the moderator psychological principle of the intervention (i.e., CBT vs Others (social skills training, mindfulness, CBM-I)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493660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8145137B-BA8F-5284-63DD-AC8F1857EA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69535" cy="6858000"/>
          </a:xfrm>
          <a:prstGeom prst="rect">
            <a:avLst/>
          </a:prstGeom>
        </p:spPr>
      </p:pic>
      <p:sp>
        <p:nvSpPr>
          <p:cNvPr id="5" name="Textfeld 4">
            <a:extLst>
              <a:ext uri="{FF2B5EF4-FFF2-40B4-BE49-F238E27FC236}">
                <a16:creationId xmlns:a16="http://schemas.microsoft.com/office/drawing/2014/main" id="{4F19A571-53A4-12C0-E1F8-F31C6CAC55BD}"/>
              </a:ext>
            </a:extLst>
          </p:cNvPr>
          <p:cNvSpPr txBox="1"/>
          <p:nvPr/>
        </p:nvSpPr>
        <p:spPr>
          <a:xfrm>
            <a:off x="288311" y="5525310"/>
            <a:ext cx="11592911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11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with the moderator SAD-specific intervention (i.e., interventions addressing SAD-specific cognitions and fears or not)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10491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22192EAC-E895-885C-B7F0-FAD5B62623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2" y="0"/>
            <a:ext cx="12169535" cy="6858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936F5781-95F1-7C27-3331-2AF7269214D8}"/>
              </a:ext>
            </a:extLst>
          </p:cNvPr>
          <p:cNvSpPr txBox="1"/>
          <p:nvPr/>
        </p:nvSpPr>
        <p:spPr>
          <a:xfrm>
            <a:off x="515007" y="5707717"/>
            <a:ext cx="10636469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12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with the moderator guidance (i.e., unguided self-help = no vs. guided self-help = yes)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421446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B7ACDC73-4F09-4BB7-5594-DEBFC0B814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32" y="0"/>
            <a:ext cx="12169535" cy="6858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3858A70B-7AC6-66CA-B046-CC5A7BC3E379}"/>
              </a:ext>
            </a:extLst>
          </p:cNvPr>
          <p:cNvSpPr txBox="1"/>
          <p:nvPr/>
        </p:nvSpPr>
        <p:spPr>
          <a:xfrm>
            <a:off x="504497" y="5031325"/>
            <a:ext cx="10941269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13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with mean age &lt;18 years with the moderator parental involvement (i.e., no support from or modules for parents = no vs. support from or modules for parents = yes)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8008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380EC35D-5106-E635-C253-93D156344E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0"/>
            <a:ext cx="11635723" cy="6557176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9B198149-9A70-4BC1-6040-5909097018EB}"/>
              </a:ext>
            </a:extLst>
          </p:cNvPr>
          <p:cNvSpPr txBox="1"/>
          <p:nvPr/>
        </p:nvSpPr>
        <p:spPr>
          <a:xfrm>
            <a:off x="620110" y="5441229"/>
            <a:ext cx="11151476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1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for the main outcome meta-analysis excluding the study with the highest effect size by Leigh and Clark (2022)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03530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43F47E51-A43A-DF53-0D2E-2A1E04BF8E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2" y="0"/>
            <a:ext cx="12169535" cy="6858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E83CD405-04C4-CD67-8CFE-8D08745A5D5E}"/>
              </a:ext>
            </a:extLst>
          </p:cNvPr>
          <p:cNvSpPr txBox="1"/>
          <p:nvPr/>
        </p:nvSpPr>
        <p:spPr>
          <a:xfrm>
            <a:off x="530771" y="5651435"/>
            <a:ext cx="11508828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2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for the main outcome meta-analysis excluding the study with the lowest effect size by </a:t>
            </a:r>
            <a:r>
              <a:rPr lang="en-GB" sz="16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alear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, </a:t>
            </a:r>
            <a:r>
              <a:rPr lang="en-GB" sz="1600" i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atterham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nd colleagues (2016)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7672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EB2CAB20-B525-136A-DA21-85AA98A91F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2" y="0"/>
            <a:ext cx="12169535" cy="6858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C72B4DFB-0318-89E6-0BB5-08DB39502FF1}"/>
              </a:ext>
            </a:extLst>
          </p:cNvPr>
          <p:cNvSpPr txBox="1"/>
          <p:nvPr/>
        </p:nvSpPr>
        <p:spPr>
          <a:xfrm>
            <a:off x="504496" y="4730255"/>
            <a:ext cx="10583917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3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for the short follow-up (3 to 6 months) meta-analysis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93627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9062BF21-7118-2862-5C3C-669D4C62E4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2" y="0"/>
            <a:ext cx="12169535" cy="6858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CAA3EE51-F36A-D8CE-8CFD-5CDF306D2488}"/>
              </a:ext>
            </a:extLst>
          </p:cNvPr>
          <p:cNvSpPr txBox="1"/>
          <p:nvPr/>
        </p:nvSpPr>
        <p:spPr>
          <a:xfrm>
            <a:off x="987972" y="4191028"/>
            <a:ext cx="10174014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latin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4</a:t>
            </a:r>
            <a:r>
              <a:rPr lang="en-GB" sz="1600" dirty="0">
                <a:latin typeface="Times New Roman" panose="02020603050405020304" pitchFamily="18" charset="0"/>
              </a:rPr>
              <a:t>. Forest plot of all studies included in the random effects model for the long follow-up (12 months) meta-analysis.</a:t>
            </a:r>
            <a:r>
              <a:rPr lang="de-CH" sz="1600" dirty="0">
                <a:latin typeface="Times New Roman" panose="02020603050405020304" pitchFamily="18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301166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AB83B71A-72C8-72C8-9E92-48CEBD28C8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65" y="105105"/>
            <a:ext cx="12169535" cy="6858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62363FD0-DD05-B57C-CC79-5F5219D98698}"/>
              </a:ext>
            </a:extLst>
          </p:cNvPr>
          <p:cNvSpPr txBox="1"/>
          <p:nvPr/>
        </p:nvSpPr>
        <p:spPr>
          <a:xfrm>
            <a:off x="767255" y="5385626"/>
            <a:ext cx="10352690" cy="14946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5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for the main outcome meta-analysis excluding studies with participants aged over 25 years (i.e., Bowler et al., (2012); Farrer et al., (2019); McCall et al., (2018); Wang et al., (2020))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876396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A2F5DD87-CD82-FE58-08D3-D6A2D9056E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2" y="0"/>
            <a:ext cx="12169535" cy="6858000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AA099E43-7CFD-129C-A76E-918B42206E3F}"/>
              </a:ext>
            </a:extLst>
          </p:cNvPr>
          <p:cNvSpPr txBox="1"/>
          <p:nvPr/>
        </p:nvSpPr>
        <p:spPr>
          <a:xfrm>
            <a:off x="756745" y="4681432"/>
            <a:ext cx="10352690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6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studies included in the random effects model for the main outcome meta-analysis omitting studies with samples in which not all participants meet clinician assessed SAD criteria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52789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1684D553-B882-9851-A0DD-12E7FA1D80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3" y="0"/>
            <a:ext cx="11749844" cy="6621488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FB9F60CB-97E8-2A7C-AD62-37A3DEDD5B1C}"/>
              </a:ext>
            </a:extLst>
          </p:cNvPr>
          <p:cNvSpPr txBox="1"/>
          <p:nvPr/>
        </p:nvSpPr>
        <p:spPr>
          <a:xfrm>
            <a:off x="567557" y="5697207"/>
            <a:ext cx="10815145" cy="100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7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with the moderator control condition (i.e., active: another intervention vs. waitlist)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17422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4F2B6072-D212-12A4-7D95-4B61369842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32" y="0"/>
            <a:ext cx="12169535" cy="6858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DB0093F4-4B7D-893F-12DB-80FBD37D5CA9}"/>
              </a:ext>
            </a:extLst>
          </p:cNvPr>
          <p:cNvSpPr txBox="1"/>
          <p:nvPr/>
        </p:nvSpPr>
        <p:spPr>
          <a:xfrm>
            <a:off x="336330" y="6089820"/>
            <a:ext cx="11046373" cy="509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457200">
              <a:lnSpc>
                <a:spcPct val="200000"/>
              </a:lnSpc>
            </a:pP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GB" sz="16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MA</a:t>
            </a:r>
            <a:r>
              <a:rPr lang="en-GB" sz="16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3.8. </a:t>
            </a:r>
            <a:r>
              <a:rPr lang="en-GB" sz="1600" i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orest plot of all studies included in the random effects model exploring the Risk of Bias. </a:t>
            </a:r>
            <a:endParaRPr lang="de-CH" sz="16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030794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d400387a-212f-43ea-ac7f-77aa12d7977e}" enabled="0" method="" siteId="{d400387a-212f-43ea-ac7f-77aa12d7977e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3</Words>
  <Application>Microsoft Macintosh PowerPoint</Application>
  <PresentationFormat>Breitbild</PresentationFormat>
  <Paragraphs>17</Paragraphs>
  <Slides>14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4</vt:i4>
      </vt:variant>
    </vt:vector>
  </HeadingPairs>
  <TitlesOfParts>
    <vt:vector size="19" baseType="lpstr">
      <vt:lpstr>Aptos</vt:lpstr>
      <vt:lpstr>Aptos Display</vt:lpstr>
      <vt:lpstr>Arial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lder, Noemi (PSY)</dc:creator>
  <cp:lastModifiedBy>Walder, Noemi (PSY)</cp:lastModifiedBy>
  <cp:revision>1</cp:revision>
  <dcterms:created xsi:type="dcterms:W3CDTF">2024-08-08T12:15:06Z</dcterms:created>
  <dcterms:modified xsi:type="dcterms:W3CDTF">2024-10-01T17:25:44Z</dcterms:modified>
</cp:coreProperties>
</file>